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wmf" ContentType="image/x-wmf"/>
  <Override PartName="/ppt/media/image13.wmf" ContentType="image/x-wmf"/>
  <Override PartName="/ppt/media/image8.jpeg" ContentType="image/jpeg"/>
  <Override PartName="/ppt/media/image5.png" ContentType="image/png"/>
  <Override PartName="/ppt/media/image9.png" ContentType="image/png"/>
  <Override PartName="/ppt/media/image17.wmf" ContentType="image/x-wmf"/>
  <Override PartName="/ppt/media/image10.wmf" ContentType="image/x-wmf"/>
  <Override PartName="/ppt/media/image20.jpeg" ContentType="image/jpeg"/>
  <Override PartName="/ppt/media/image19.wmf" ContentType="image/x-wmf"/>
  <Override PartName="/ppt/media/image18.wmf" ContentType="image/x-wmf"/>
  <Override PartName="/ppt/media/image3.jpeg" ContentType="image/jpeg"/>
  <Override PartName="/ppt/media/image16.wmf" ContentType="image/x-wmf"/>
  <Override PartName="/ppt/media/image14.wmf" ContentType="image/x-wmf"/>
  <Override PartName="/ppt/media/image15.wmf" ContentType="image/x-wmf"/>
  <Override PartName="/ppt/media/image1.jpeg" ContentType="image/jpeg"/>
  <Override PartName="/ppt/media/image2.jpeg" ContentType="image/jpeg"/>
  <Override PartName="/ppt/media/image6.jpeg" ContentType="image/jpeg"/>
  <Override PartName="/ppt/media/image12.wmf" ContentType="image/x-wmf"/>
  <Override PartName="/ppt/media/image4.png" ContentType="image/png"/>
  <Override PartName="/ppt/media/image7.jpeg" ContentType="image/jpe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8160" y="744120"/>
            <a:ext cx="2578320" cy="3724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D42750-90AB-4F2A-93D5-6E56F6CCEB56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48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sv-S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Platshållare för bild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5491D0-1511-4933-A151-1DBA2F1782E6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51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Platshållare för bild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468ED4-BADA-4E25-976C-38C9AD0FD569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54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latshållare för bild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93AED4-5BE6-465F-92D9-6AA3D69E2540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57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sv-S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Platshållare för bild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ACAE50-4519-4652-B92E-D0570BE14F13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60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sv-S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tshållare för bild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10A88A-8C0A-431F-9EEF-EF758CB75606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63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sv-S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Platshållare för bild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0CEB8F-E670-4FCD-B474-ABF78444136B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66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tshållare för bild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9FFFE1-5C4B-40F9-87C4-240D76539804}" type="slidenum">
              <a:rPr b="0" lang="sv-S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AC6CD-EBD1-425F-8245-693FF04EDE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B27C4-C210-40E1-905E-54823DF690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99C5E6-0A79-4182-9C63-8980B68FD6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DA861-1F5B-4267-AD9E-17B1083C4D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866C3-E2CF-4349-AA01-0C025DA9AB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F7C10-38A8-4091-BCED-DB9535721E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D0398-1068-4425-8B41-AD0FA7C0D4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B1EAC-9051-4C44-BCFF-EA3A998958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0D6C8-71C3-46E4-B5F3-39F751B4C6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5EDBB7-7319-4453-956C-8654392E68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23617-3539-40C7-9C8B-E6A9772AAF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8FE2C-0616-4502-A645-1BAC5795AA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40CF3A-5CC0-4982-AD58-0DDDADE79434}" type="slidenum">
              <a:rPr b="0" lang="sv-S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9.png"/><Relationship Id="rId6" Type="http://schemas.openxmlformats.org/officeDocument/2006/relationships/image" Target="../media/image9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0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1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2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3.wmf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5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7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8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9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0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2053800" y="488880"/>
            <a:ext cx="251388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sv-SE" sz="900" spc="-1" strike="noStrike">
                <a:solidFill>
                  <a:srgbClr val="000000"/>
                </a:solidFill>
                <a:latin typeface="Calibri"/>
              </a:rPr>
              <a:t>Postmenopausal breast cancer patients included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sv-SE" sz="900" spc="-1" strike="noStrike">
                <a:solidFill>
                  <a:srgbClr val="000000"/>
                </a:solidFill>
                <a:latin typeface="Calibri"/>
              </a:rPr>
              <a:t>in the original Stockholm tamoxifen tria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2459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>
            <a:off x="1592280" y="1644480"/>
            <a:ext cx="109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sv-SE" sz="900" spc="-1" strike="noStrike">
                <a:solidFill>
                  <a:srgbClr val="000000"/>
                </a:solidFill>
                <a:latin typeface="Calibri"/>
              </a:rPr>
              <a:t>Stockholm 2 cohor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679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6"/>
          <p:cNvSpPr/>
          <p:nvPr/>
        </p:nvSpPr>
        <p:spPr>
          <a:xfrm>
            <a:off x="4170240" y="1644480"/>
            <a:ext cx="133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sv-SE" sz="900" spc="-1" strike="noStrike">
                <a:solidFill>
                  <a:srgbClr val="000000"/>
                </a:solidFill>
                <a:latin typeface="Calibri"/>
              </a:rPr>
              <a:t>Stockholm 3 cohor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178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1191600" y="221472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Tam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349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8"/>
          <p:cNvSpPr/>
          <p:nvPr/>
        </p:nvSpPr>
        <p:spPr>
          <a:xfrm>
            <a:off x="3950640" y="222084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Tam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886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"/>
          <p:cNvSpPr/>
          <p:nvPr/>
        </p:nvSpPr>
        <p:spPr>
          <a:xfrm>
            <a:off x="2490480" y="221472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no Ta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33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0"/>
          <p:cNvSpPr/>
          <p:nvPr/>
        </p:nvSpPr>
        <p:spPr>
          <a:xfrm>
            <a:off x="5249520" y="222084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no Ta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894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1"/>
          <p:cNvSpPr/>
          <p:nvPr/>
        </p:nvSpPr>
        <p:spPr>
          <a:xfrm>
            <a:off x="769320" y="301320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RT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16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2"/>
          <p:cNvSpPr/>
          <p:nvPr/>
        </p:nvSpPr>
        <p:spPr>
          <a:xfrm>
            <a:off x="2787120" y="3013200"/>
            <a:ext cx="54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CMF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182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3"/>
          <p:cNvSpPr/>
          <p:nvPr/>
        </p:nvSpPr>
        <p:spPr>
          <a:xfrm>
            <a:off x="2111400" y="3013200"/>
            <a:ext cx="64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RT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148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4"/>
          <p:cNvSpPr/>
          <p:nvPr/>
        </p:nvSpPr>
        <p:spPr>
          <a:xfrm>
            <a:off x="1440000" y="3014640"/>
            <a:ext cx="63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CMF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189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5"/>
          <p:cNvSpPr/>
          <p:nvPr/>
        </p:nvSpPr>
        <p:spPr>
          <a:xfrm flipH="1">
            <a:off x="2192040" y="1015920"/>
            <a:ext cx="1012680" cy="628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6"/>
          <p:cNvSpPr/>
          <p:nvPr/>
        </p:nvSpPr>
        <p:spPr>
          <a:xfrm>
            <a:off x="3400560" y="1015920"/>
            <a:ext cx="1185840" cy="628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8"/>
          <p:cNvSpPr/>
          <p:nvPr/>
        </p:nvSpPr>
        <p:spPr>
          <a:xfrm>
            <a:off x="2602080" y="2004840"/>
            <a:ext cx="79200" cy="209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1"/>
          <p:cNvSpPr/>
          <p:nvPr/>
        </p:nvSpPr>
        <p:spPr>
          <a:xfrm flipH="1">
            <a:off x="1190520" y="2671920"/>
            <a:ext cx="239760" cy="341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2"/>
          <p:cNvSpPr/>
          <p:nvPr/>
        </p:nvSpPr>
        <p:spPr>
          <a:xfrm>
            <a:off x="1523880" y="2671920"/>
            <a:ext cx="195480" cy="341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5"/>
          <p:cNvSpPr/>
          <p:nvPr/>
        </p:nvSpPr>
        <p:spPr>
          <a:xfrm flipH="1">
            <a:off x="2440080" y="2671920"/>
            <a:ext cx="241200" cy="341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7"/>
          <p:cNvSpPr/>
          <p:nvPr/>
        </p:nvSpPr>
        <p:spPr>
          <a:xfrm>
            <a:off x="2778120" y="2671920"/>
            <a:ext cx="190440" cy="341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8"/>
          <p:cNvSpPr/>
          <p:nvPr/>
        </p:nvSpPr>
        <p:spPr>
          <a:xfrm flipH="1">
            <a:off x="1507680" y="2004840"/>
            <a:ext cx="142920" cy="209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9"/>
          <p:cNvSpPr/>
          <p:nvPr/>
        </p:nvSpPr>
        <p:spPr>
          <a:xfrm flipH="1">
            <a:off x="4243320" y="2004840"/>
            <a:ext cx="138240" cy="216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0"/>
          <p:cNvSpPr/>
          <p:nvPr/>
        </p:nvSpPr>
        <p:spPr>
          <a:xfrm>
            <a:off x="5200560" y="2004840"/>
            <a:ext cx="138240" cy="216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4"/>
          <p:cNvSpPr/>
          <p:nvPr/>
        </p:nvSpPr>
        <p:spPr>
          <a:xfrm>
            <a:off x="3286080" y="2725560"/>
            <a:ext cx="3022560" cy="242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900" spc="-1" strike="noStrike">
                <a:solidFill>
                  <a:srgbClr val="000000"/>
                </a:solidFill>
                <a:latin typeface="Calibri"/>
              </a:rPr>
              <a:t>Tumours available for TMA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900" spc="-1" strike="noStrike">
                <a:solidFill>
                  <a:srgbClr val="000000"/>
                </a:solidFill>
                <a:latin typeface="Calibri"/>
              </a:rPr>
              <a:t>preparation and protein IHC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(n=912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Calibri"/>
              </a:rPr>
              <a:t>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9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ktangel med rundade hörn 170"/>
          <p:cNvSpPr/>
          <p:nvPr/>
        </p:nvSpPr>
        <p:spPr>
          <a:xfrm>
            <a:off x="3832200" y="2725560"/>
            <a:ext cx="2054160" cy="6494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7"/>
          <p:cNvSpPr/>
          <p:nvPr/>
        </p:nvSpPr>
        <p:spPr>
          <a:xfrm>
            <a:off x="358920" y="3886200"/>
            <a:ext cx="6048360" cy="137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atient flow through the study; the randomised Stockholm tamoxifen trial, Stockholm 2 and Stockholm 3 cohorts. (Tam: tamoxifen, RT: radiotherapy, CMF: cyclophosphamide metotrexate, 5-fluorouracil chemotherapy, TMA: tissue microarray, IHC: immunohistochemistry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6" descr="C:\Documents and Settings\elika34\Skrivbord\Säkerhetskopieras EJ\tot4EBP1\1\1835.tif"/>
          <p:cNvPicPr/>
          <p:nvPr/>
        </p:nvPicPr>
        <p:blipFill>
          <a:blip r:embed="rId1"/>
          <a:stretch/>
        </p:blipFill>
        <p:spPr>
          <a:xfrm>
            <a:off x="2997360" y="1208160"/>
            <a:ext cx="2468520" cy="215892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7" descr="C:\Documents and Settings\elika34\Skrivbord\Säkerhetskopieras EJ\tot4EBP1\10\682.tif"/>
          <p:cNvPicPr/>
          <p:nvPr/>
        </p:nvPicPr>
        <p:blipFill>
          <a:blip r:embed="rId2"/>
          <a:stretch/>
        </p:blipFill>
        <p:spPr>
          <a:xfrm>
            <a:off x="549360" y="3368520"/>
            <a:ext cx="2468520" cy="215928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8" descr="C:\Documents and Settings\elika34\Skrivbord\Säkerhetskopieras EJ\tot4EBP1\11\980.tif"/>
          <p:cNvPicPr/>
          <p:nvPr/>
        </p:nvPicPr>
        <p:blipFill>
          <a:blip r:embed="rId3"/>
          <a:stretch/>
        </p:blipFill>
        <p:spPr>
          <a:xfrm>
            <a:off x="549360" y="1208160"/>
            <a:ext cx="2468520" cy="2158920"/>
          </a:xfrm>
          <a:prstGeom prst="rect">
            <a:avLst/>
          </a:prstGeom>
          <a:ln w="0">
            <a:noFill/>
          </a:ln>
        </p:spPr>
      </p:pic>
      <p:sp>
        <p:nvSpPr>
          <p:cNvPr id="75" name="Text Box 11"/>
          <p:cNvSpPr/>
          <p:nvPr/>
        </p:nvSpPr>
        <p:spPr>
          <a:xfrm>
            <a:off x="555840" y="1208160"/>
            <a:ext cx="29952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1"/>
          <p:cNvSpPr/>
          <p:nvPr/>
        </p:nvSpPr>
        <p:spPr>
          <a:xfrm>
            <a:off x="3003120" y="1208160"/>
            <a:ext cx="30708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1"/>
          <p:cNvSpPr/>
          <p:nvPr/>
        </p:nvSpPr>
        <p:spPr>
          <a:xfrm>
            <a:off x="556200" y="3368520"/>
            <a:ext cx="29052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1"/>
          <p:cNvSpPr/>
          <p:nvPr/>
        </p:nvSpPr>
        <p:spPr>
          <a:xfrm>
            <a:off x="3003120" y="3368520"/>
            <a:ext cx="30708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ruta 46"/>
          <p:cNvSpPr/>
          <p:nvPr/>
        </p:nvSpPr>
        <p:spPr>
          <a:xfrm>
            <a:off x="549360" y="6105600"/>
            <a:ext cx="5040360" cy="173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Times New Roman"/>
              </a:rPr>
              <a:t>Supplementary Figure 2 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</a:rPr>
              <a:t>Examples of tumours graded for 4EBP1 nuclear and cytoplasmic staining; negative/weak (a); intermediate (b); and strong 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</a:rPr>
              <a:t>staining (c);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</a:rPr>
              <a:t> validation of 4EBP1 antibody specificity using immunoblot with MCF7 cell lysate (d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18" descr=""/>
          <p:cNvPicPr/>
          <p:nvPr/>
        </p:nvPicPr>
        <p:blipFill>
          <a:blip r:embed="rId4"/>
          <a:srcRect l="0" t="19697" r="0" b="0"/>
          <a:stretch/>
        </p:blipFill>
        <p:spPr>
          <a:xfrm>
            <a:off x="3645000" y="3368520"/>
            <a:ext cx="809640" cy="2160720"/>
          </a:xfrm>
          <a:prstGeom prst="rect">
            <a:avLst/>
          </a:prstGeom>
          <a:ln w="0">
            <a:noFill/>
          </a:ln>
        </p:spPr>
      </p:pic>
      <p:sp>
        <p:nvSpPr>
          <p:cNvPr id="81" name="Text Box 19"/>
          <p:cNvSpPr/>
          <p:nvPr/>
        </p:nvSpPr>
        <p:spPr>
          <a:xfrm>
            <a:off x="3068640" y="488160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0"/>
          <p:cNvSpPr/>
          <p:nvPr/>
        </p:nvSpPr>
        <p:spPr>
          <a:xfrm>
            <a:off x="3860640" y="5240160"/>
            <a:ext cx="65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4EB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21"/>
          <p:cNvSpPr/>
          <p:nvPr/>
        </p:nvSpPr>
        <p:spPr>
          <a:xfrm>
            <a:off x="2997360" y="3368520"/>
            <a:ext cx="2447640" cy="2160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22"/>
          <p:cNvSpPr/>
          <p:nvPr/>
        </p:nvSpPr>
        <p:spPr>
          <a:xfrm>
            <a:off x="3645000" y="50245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2" descr=""/>
          <p:cNvPicPr/>
          <p:nvPr/>
        </p:nvPicPr>
        <p:blipFill>
          <a:blip r:embed="rId1"/>
          <a:srcRect l="63167" t="50962" r="25156" b="0"/>
          <a:stretch/>
        </p:blipFill>
        <p:spPr>
          <a:xfrm>
            <a:off x="3645000" y="2865600"/>
            <a:ext cx="720720" cy="237636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4" descr="1514"/>
          <p:cNvPicPr/>
          <p:nvPr/>
        </p:nvPicPr>
        <p:blipFill>
          <a:blip r:embed="rId2"/>
          <a:stretch/>
        </p:blipFill>
        <p:spPr>
          <a:xfrm>
            <a:off x="476280" y="920880"/>
            <a:ext cx="2469960" cy="215892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4" descr="1096"/>
          <p:cNvPicPr/>
          <p:nvPr/>
        </p:nvPicPr>
        <p:blipFill>
          <a:blip r:embed="rId3"/>
          <a:stretch/>
        </p:blipFill>
        <p:spPr>
          <a:xfrm>
            <a:off x="2924280" y="920880"/>
            <a:ext cx="2469960" cy="215892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5" descr="C:\Documents and Settings\elika34\Skrivbord\Säkerhetskopieras EJ\p4EBP1 nya glas 120628\p4EBP1 glas 13 ny 120629\2574.tif"/>
          <p:cNvPicPr/>
          <p:nvPr/>
        </p:nvPicPr>
        <p:blipFill>
          <a:blip r:embed="rId4"/>
          <a:stretch/>
        </p:blipFill>
        <p:spPr>
          <a:xfrm>
            <a:off x="476280" y="3081240"/>
            <a:ext cx="2448000" cy="215892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6" descr=""/>
          <p:cNvPicPr/>
          <p:nvPr/>
        </p:nvPicPr>
        <p:blipFill>
          <a:blip r:embed="rId5"/>
          <a:srcRect l="0" t="7458" r="49288" b="0"/>
          <a:stretch/>
        </p:blipFill>
        <p:spPr>
          <a:xfrm>
            <a:off x="476280" y="5240160"/>
            <a:ext cx="2448000" cy="215928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7" descr=""/>
          <p:cNvPicPr/>
          <p:nvPr/>
        </p:nvPicPr>
        <p:blipFill>
          <a:blip r:embed="rId6"/>
          <a:srcRect l="50719" t="7458" r="0" b="0"/>
          <a:stretch/>
        </p:blipFill>
        <p:spPr>
          <a:xfrm>
            <a:off x="2924280" y="5240160"/>
            <a:ext cx="2394000" cy="2159280"/>
          </a:xfrm>
          <a:prstGeom prst="rect">
            <a:avLst/>
          </a:prstGeom>
          <a:ln w="0">
            <a:noFill/>
          </a:ln>
        </p:spPr>
      </p:pic>
      <p:sp>
        <p:nvSpPr>
          <p:cNvPr id="91" name="Text Box 11"/>
          <p:cNvSpPr/>
          <p:nvPr/>
        </p:nvSpPr>
        <p:spPr>
          <a:xfrm>
            <a:off x="482760" y="920880"/>
            <a:ext cx="29952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0"/>
          <p:cNvSpPr/>
          <p:nvPr/>
        </p:nvSpPr>
        <p:spPr>
          <a:xfrm>
            <a:off x="2930040" y="920880"/>
            <a:ext cx="30708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1"/>
          <p:cNvSpPr/>
          <p:nvPr/>
        </p:nvSpPr>
        <p:spPr>
          <a:xfrm>
            <a:off x="483480" y="3081240"/>
            <a:ext cx="29052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2"/>
          <p:cNvSpPr/>
          <p:nvPr/>
        </p:nvSpPr>
        <p:spPr>
          <a:xfrm>
            <a:off x="482760" y="5240160"/>
            <a:ext cx="30276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3"/>
          <p:cNvSpPr/>
          <p:nvPr/>
        </p:nvSpPr>
        <p:spPr>
          <a:xfrm>
            <a:off x="404640" y="7545240"/>
            <a:ext cx="5721480" cy="146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Times New Roman"/>
              </a:rPr>
              <a:t>Supplementary Figure 3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</a:rPr>
              <a:t> Examples of tumours graded for p4EBP1_S65 nuclear and cytoplasmic staining: negative/weak (a); intermediate (b) and strong staining (c);  validation of p4EBP1_S65 antibody specificity; immunoblot using MCF7 cell lysate (d);  p4EBP1 breast tumour tissue staining: control without lambda-phosphatase (e) and with lambda-phosphatase (f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4"/>
          <p:cNvSpPr/>
          <p:nvPr/>
        </p:nvSpPr>
        <p:spPr>
          <a:xfrm>
            <a:off x="2930040" y="5240160"/>
            <a:ext cx="27360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6"/>
          <p:cNvSpPr/>
          <p:nvPr/>
        </p:nvSpPr>
        <p:spPr>
          <a:xfrm>
            <a:off x="2852640" y="452124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18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7"/>
          <p:cNvSpPr/>
          <p:nvPr/>
        </p:nvSpPr>
        <p:spPr>
          <a:xfrm>
            <a:off x="3642120" y="4952880"/>
            <a:ext cx="110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p4EBP1_S6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8"/>
          <p:cNvSpPr/>
          <p:nvPr/>
        </p:nvSpPr>
        <p:spPr>
          <a:xfrm>
            <a:off x="2924280" y="3081240"/>
            <a:ext cx="2449440" cy="2158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20"/>
          <p:cNvSpPr/>
          <p:nvPr/>
        </p:nvSpPr>
        <p:spPr>
          <a:xfrm>
            <a:off x="3429000" y="46656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1"/>
          <p:cNvSpPr/>
          <p:nvPr/>
        </p:nvSpPr>
        <p:spPr>
          <a:xfrm>
            <a:off x="2930040" y="3081240"/>
            <a:ext cx="30708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" name="Object 2"/>
          <p:cNvGraphicFramePr/>
          <p:nvPr/>
        </p:nvGraphicFramePr>
        <p:xfrm>
          <a:off x="260280" y="704880"/>
          <a:ext cx="3119400" cy="2340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60280" y="704880"/>
                    <a:ext cx="311940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4" name="Object 3"/>
          <p:cNvGraphicFramePr/>
          <p:nvPr/>
        </p:nvGraphicFramePr>
        <p:xfrm>
          <a:off x="3500280" y="704880"/>
          <a:ext cx="3119760" cy="2340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5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500280" y="704880"/>
                    <a:ext cx="311976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6" name="Object 4"/>
          <p:cNvGraphicFramePr/>
          <p:nvPr/>
        </p:nvGraphicFramePr>
        <p:xfrm>
          <a:off x="260280" y="3944880"/>
          <a:ext cx="3119400" cy="23400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7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60280" y="3944880"/>
                    <a:ext cx="311940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8" name="Object 6"/>
          <p:cNvGraphicFramePr/>
          <p:nvPr/>
        </p:nvGraphicFramePr>
        <p:xfrm>
          <a:off x="3500280" y="3944880"/>
          <a:ext cx="3121200" cy="23400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9" name="Object 6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500280" y="3944880"/>
                    <a:ext cx="312120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0" name="Text Box 11"/>
          <p:cNvSpPr/>
          <p:nvPr/>
        </p:nvSpPr>
        <p:spPr>
          <a:xfrm>
            <a:off x="486000" y="70488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2"/>
          <p:cNvSpPr/>
          <p:nvPr/>
        </p:nvSpPr>
        <p:spPr>
          <a:xfrm>
            <a:off x="3722400" y="70488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13"/>
          <p:cNvSpPr/>
          <p:nvPr/>
        </p:nvSpPr>
        <p:spPr>
          <a:xfrm>
            <a:off x="486360" y="3944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14"/>
          <p:cNvSpPr/>
          <p:nvPr/>
        </p:nvSpPr>
        <p:spPr>
          <a:xfrm>
            <a:off x="3795120" y="401652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ktangel 12"/>
          <p:cNvSpPr/>
          <p:nvPr/>
        </p:nvSpPr>
        <p:spPr>
          <a:xfrm>
            <a:off x="3794760" y="3081240"/>
            <a:ext cx="23144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S6K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1.21 (0.73-2.0), p=0.4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DRFS: HR (95%CI)=1.31 (0.84-2.02), p=0.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ktangel 12"/>
          <p:cNvSpPr/>
          <p:nvPr/>
        </p:nvSpPr>
        <p:spPr>
          <a:xfrm>
            <a:off x="555120" y="3081240"/>
            <a:ext cx="237240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S6K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1.56 (0.94-2.56), p=0.08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DRFS: HR (95%CI)=1.63 (1.06-2.49), p=0.02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ktangel 12"/>
          <p:cNvSpPr/>
          <p:nvPr/>
        </p:nvSpPr>
        <p:spPr>
          <a:xfrm>
            <a:off x="554760" y="6321600"/>
            <a:ext cx="2459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S6K2 media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2.0 (1.21-3.29), p=0.006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DRFS: HR (95%CI)= 1.96 (1.29-2.98), p=0.00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ktangel 12"/>
          <p:cNvSpPr/>
          <p:nvPr/>
        </p:nvSpPr>
        <p:spPr>
          <a:xfrm>
            <a:off x="3795120" y="6321600"/>
            <a:ext cx="240120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4EBP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1.83 (1.10-3.05), p=0.01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DRFS: HR (95%CI)= 1.78 (1.15-2.78), p=0.0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1061"/>
          <p:cNvSpPr/>
          <p:nvPr/>
        </p:nvSpPr>
        <p:spPr>
          <a:xfrm>
            <a:off x="476280" y="7184880"/>
            <a:ext cx="5977080" cy="21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4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Kaplan-Meier curves and multivariate Cox regression of breast cancer survival (BCS) and distant recurrence-free survival (DRFS) in the van de Vijver patient cohort, in relation to; S6K1 mRNA (a); S6K2 mRNA; (b) S6K2 mRNA median (c); and 4EBP1 mRNA (d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Cox analysis included the following variables: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juvant chemotherapy treatment, endocrine treatment, lymph node status, and ER statu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9" name="Object 3"/>
          <p:cNvGraphicFramePr/>
          <p:nvPr/>
        </p:nvGraphicFramePr>
        <p:xfrm>
          <a:off x="3429000" y="849240"/>
          <a:ext cx="3119400" cy="2340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20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429000" y="849240"/>
                    <a:ext cx="311940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1" name="Object 4"/>
          <p:cNvGraphicFramePr/>
          <p:nvPr/>
        </p:nvGraphicFramePr>
        <p:xfrm>
          <a:off x="404640" y="3728880"/>
          <a:ext cx="3119760" cy="2340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22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04640" y="3728880"/>
                    <a:ext cx="311976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3" name="Object 5"/>
          <p:cNvGraphicFramePr/>
          <p:nvPr/>
        </p:nvGraphicFramePr>
        <p:xfrm>
          <a:off x="404640" y="849240"/>
          <a:ext cx="3121200" cy="23400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24" name="Object 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04640" y="849240"/>
                    <a:ext cx="312120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5" name="Text Box 11"/>
          <p:cNvSpPr/>
          <p:nvPr/>
        </p:nvSpPr>
        <p:spPr>
          <a:xfrm>
            <a:off x="694080" y="84924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12"/>
          <p:cNvSpPr/>
          <p:nvPr/>
        </p:nvSpPr>
        <p:spPr>
          <a:xfrm>
            <a:off x="3717360" y="84924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13"/>
          <p:cNvSpPr/>
          <p:nvPr/>
        </p:nvSpPr>
        <p:spPr>
          <a:xfrm>
            <a:off x="631080" y="3728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1061"/>
          <p:cNvSpPr/>
          <p:nvPr/>
        </p:nvSpPr>
        <p:spPr>
          <a:xfrm>
            <a:off x="404640" y="6537240"/>
            <a:ext cx="6264360" cy="185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5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Kaplan-Meier curves and multivariate Cox regression of breast cancer survival (BCS) in the Karolinska patient cohort, in relation to S6K1 mRNA (a); S6K2 mRNA (b); and 4EBP1mRNA (c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Cox analysis included the following variables: 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juvant chemotherapy treatment, endocrine treatment, lymph node status, tumour size and ER statu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ktangel 12"/>
          <p:cNvSpPr/>
          <p:nvPr/>
        </p:nvSpPr>
        <p:spPr>
          <a:xfrm>
            <a:off x="3650400" y="3224160"/>
            <a:ext cx="230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S6K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2.27 (1.04-4.93), p=0.03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ktangel 12"/>
          <p:cNvSpPr/>
          <p:nvPr/>
        </p:nvSpPr>
        <p:spPr>
          <a:xfrm>
            <a:off x="626400" y="3224160"/>
            <a:ext cx="224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S6K1: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0.90 (0.37-2.15), p=0.8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ktangel 12"/>
          <p:cNvSpPr/>
          <p:nvPr/>
        </p:nvSpPr>
        <p:spPr>
          <a:xfrm>
            <a:off x="626400" y="6032520"/>
            <a:ext cx="238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4EBP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3.19 (1.43-7.15), p=0.0047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2" name="Object 2"/>
          <p:cNvGraphicFramePr/>
          <p:nvPr/>
        </p:nvGraphicFramePr>
        <p:xfrm>
          <a:off x="404640" y="3297240"/>
          <a:ext cx="3119760" cy="2340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04640" y="3297240"/>
                    <a:ext cx="311976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4" name="Object 3"/>
          <p:cNvGraphicFramePr/>
          <p:nvPr/>
        </p:nvGraphicFramePr>
        <p:xfrm>
          <a:off x="3500280" y="415800"/>
          <a:ext cx="3119760" cy="2340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35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500280" y="415800"/>
                    <a:ext cx="311976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6" name="Object 4"/>
          <p:cNvGraphicFramePr/>
          <p:nvPr/>
        </p:nvGraphicFramePr>
        <p:xfrm>
          <a:off x="404640" y="415800"/>
          <a:ext cx="3121200" cy="23400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37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04640" y="415800"/>
                    <a:ext cx="312120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8" name="Text Box 11"/>
          <p:cNvSpPr/>
          <p:nvPr/>
        </p:nvSpPr>
        <p:spPr>
          <a:xfrm>
            <a:off x="622440" y="48888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12"/>
          <p:cNvSpPr/>
          <p:nvPr/>
        </p:nvSpPr>
        <p:spPr>
          <a:xfrm>
            <a:off x="3795120" y="48888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13"/>
          <p:cNvSpPr/>
          <p:nvPr/>
        </p:nvSpPr>
        <p:spPr>
          <a:xfrm>
            <a:off x="694440" y="3368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Calibri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1061"/>
          <p:cNvSpPr/>
          <p:nvPr/>
        </p:nvSpPr>
        <p:spPr>
          <a:xfrm>
            <a:off x="404640" y="6176880"/>
            <a:ext cx="6120000" cy="185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6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Kaplan-Meier curves and multivariate Cox regression of breast cancer survival (BCS) in the Uppsala patient cohort, in relation to S6K1 mRNA (a); S6K2 mRNA (b); and 4EBP1mRNA (c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Cox analysis included the following variables: 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juvant chemotherapy treatment, endocrine treatment, lymph node status, tumour size, and ER statu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ktangel 12"/>
          <p:cNvSpPr/>
          <p:nvPr/>
        </p:nvSpPr>
        <p:spPr>
          <a:xfrm>
            <a:off x="3795120" y="2720880"/>
            <a:ext cx="224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S6K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1.34 (0.71-2.54), p=0.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ktangel 12"/>
          <p:cNvSpPr/>
          <p:nvPr/>
        </p:nvSpPr>
        <p:spPr>
          <a:xfrm>
            <a:off x="626400" y="2720880"/>
            <a:ext cx="227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S6K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0.72 (0.36-1.43), p=0.35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ktangel 12"/>
          <p:cNvSpPr/>
          <p:nvPr/>
        </p:nvSpPr>
        <p:spPr>
          <a:xfrm>
            <a:off x="627480" y="5600880"/>
            <a:ext cx="228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 baseline="30000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4EBP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sv-SE" sz="900" spc="-1" strike="noStrike">
                <a:solidFill>
                  <a:srgbClr val="000000"/>
                </a:solidFill>
                <a:latin typeface="Times New Roman"/>
              </a:rPr>
              <a:t>BCS: HR (95%CI)=1.47 (0.79-2.73), p=0.22</a:t>
            </a:r>
            <a:r>
              <a:rPr b="0" lang="sv-SE" sz="900" spc="-1" strike="noStrike" baseline="30000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 Box 1061"/>
          <p:cNvSpPr/>
          <p:nvPr/>
        </p:nvSpPr>
        <p:spPr>
          <a:xfrm>
            <a:off x="260280" y="5673600"/>
            <a:ext cx="6120000" cy="149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7 </a:t>
            </a:r>
            <a:r>
              <a:rPr b="0" lang="sv-S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verview of suggested 4EBP1 signalling pathways, based on results from this study and previous literatur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Bildobjekt 3" descr="4EBP1 signalväg till manus.jpg"/>
          <p:cNvPicPr/>
          <p:nvPr/>
        </p:nvPicPr>
        <p:blipFill>
          <a:blip r:embed="rId1"/>
          <a:stretch/>
        </p:blipFill>
        <p:spPr>
          <a:xfrm>
            <a:off x="0" y="344520"/>
            <a:ext cx="6808680" cy="519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16T05:58:08Z</dcterms:created>
  <dc:creator>elika34</dc:creator>
  <dc:description/>
  <dc:language>en-US</dc:language>
  <cp:lastModifiedBy>Elin Karlsson</cp:lastModifiedBy>
  <dcterms:modified xsi:type="dcterms:W3CDTF">2013-06-14T07:02:01Z</dcterms:modified>
  <cp:revision>296</cp:revision>
  <dc:subject/>
  <dc:title>Bild 1</dc:title>
</cp:coreProperties>
</file>